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94" r:id="rId3"/>
    <p:sldId id="295" r:id="rId4"/>
    <p:sldId id="296" r:id="rId5"/>
    <p:sldId id="297" r:id="rId6"/>
    <p:sldId id="298" r:id="rId7"/>
    <p:sldId id="299" r:id="rId8"/>
    <p:sldId id="300" r:id="rId9"/>
    <p:sldId id="301" r:id="rId10"/>
    <p:sldId id="302" r:id="rId11"/>
    <p:sldId id="303" r:id="rId12"/>
    <p:sldId id="304" r:id="rId13"/>
    <p:sldId id="305" r:id="rId14"/>
    <p:sldId id="306" r:id="rId15"/>
    <p:sldId id="307" r:id="rId16"/>
    <p:sldId id="308" r:id="rId17"/>
    <p:sldId id="309" r:id="rId18"/>
    <p:sldId id="310" r:id="rId19"/>
    <p:sldId id="311" r:id="rId20"/>
    <p:sldId id="312" r:id="rId21"/>
    <p:sldId id="314" r:id="rId22"/>
    <p:sldId id="313" r:id="rId23"/>
    <p:sldId id="315" r:id="rId24"/>
    <p:sldId id="316" r:id="rId25"/>
    <p:sldId id="317" r:id="rId26"/>
    <p:sldId id="318" r:id="rId27"/>
    <p:sldId id="319" r:id="rId2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1" Type="http://schemas.openxmlformats.org/officeDocument/2006/relationships/tableStyles" Target="tableStyles.xml"/><Relationship Id="rId30" Type="http://schemas.openxmlformats.org/officeDocument/2006/relationships/viewProps" Target="viewProps.xml"/><Relationship Id="rId3" Type="http://schemas.openxmlformats.org/officeDocument/2006/relationships/slide" Target="slides/slide1.xml"/><Relationship Id="rId29" Type="http://schemas.openxmlformats.org/officeDocument/2006/relationships/presProps" Target="presProps.xml"/><Relationship Id="rId28" Type="http://schemas.openxmlformats.org/officeDocument/2006/relationships/slide" Target="slides/slide26.xml"/><Relationship Id="rId27" Type="http://schemas.openxmlformats.org/officeDocument/2006/relationships/slide" Target="slides/slide25.xml"/><Relationship Id="rId26" Type="http://schemas.openxmlformats.org/officeDocument/2006/relationships/slide" Target="slides/slide24.xml"/><Relationship Id="rId25" Type="http://schemas.openxmlformats.org/officeDocument/2006/relationships/slide" Target="slides/slide23.xml"/><Relationship Id="rId24" Type="http://schemas.openxmlformats.org/officeDocument/2006/relationships/slide" Target="slides/slide22.xml"/><Relationship Id="rId23" Type="http://schemas.openxmlformats.org/officeDocument/2006/relationships/slide" Target="slides/slide21.xml"/><Relationship Id="rId22" Type="http://schemas.openxmlformats.org/officeDocument/2006/relationships/slide" Target="slides/slide20.xml"/><Relationship Id="rId21" Type="http://schemas.openxmlformats.org/officeDocument/2006/relationships/slide" Target="slides/slide19.xml"/><Relationship Id="rId20" Type="http://schemas.openxmlformats.org/officeDocument/2006/relationships/slide" Target="slides/slide18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1.png"/><Relationship Id="rId1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3.png"/><Relationship Id="rId1" Type="http://schemas.openxmlformats.org/officeDocument/2006/relationships/image" Target="../media/image12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4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7.png"/><Relationship Id="rId1" Type="http://schemas.openxmlformats.org/officeDocument/2006/relationships/image" Target="../media/image1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19.png"/><Relationship Id="rId1" Type="http://schemas.openxmlformats.org/officeDocument/2006/relationships/image" Target="../media/image1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1.png"/><Relationship Id="rId1" Type="http://schemas.openxmlformats.org/officeDocument/2006/relationships/image" Target="../media/image20.png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2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4.png"/><Relationship Id="rId1" Type="http://schemas.openxmlformats.org/officeDocument/2006/relationships/image" Target="../media/image23.png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7.png"/><Relationship Id="rId1" Type="http://schemas.openxmlformats.org/officeDocument/2006/relationships/image" Target="../media/image26.png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8.pn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9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1.png"/><Relationship Id="rId1" Type="http://schemas.openxmlformats.org/officeDocument/2006/relationships/image" Target="../media/image30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3.png"/><Relationship Id="rId1" Type="http://schemas.openxmlformats.org/officeDocument/2006/relationships/image" Target="../media/image32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5.png"/><Relationship Id="rId1" Type="http://schemas.openxmlformats.org/officeDocument/2006/relationships/image" Target="../media/image34.pn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37.png"/><Relationship Id="rId1" Type="http://schemas.openxmlformats.org/officeDocument/2006/relationships/image" Target="../media/image36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1090295" y="131318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096000" y="36963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115685" y="34563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094730" y="33470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085205" y="31838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063615" y="30486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096000" y="43840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096000" y="41751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109335" y="39839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111240" y="38398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478915" y="373189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379855" y="300990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ZO-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195060" y="735965"/>
            <a:ext cx="5875020" cy="410718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7985" y="673735"/>
            <a:ext cx="5875020" cy="410718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62000" y="26974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3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62000" y="25723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6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24865" y="24542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787400" y="31051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3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782320" y="29730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68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787400" y="28619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9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782320" y="32238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512560" y="25514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3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512560" y="24263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6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575425" y="23082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537960" y="29591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3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532880" y="28270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68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537960" y="27158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9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532880" y="30778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251450" y="338074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465445" y="251079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C2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1126470" y="242633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pACC2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1038205" y="310261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945" y="1162685"/>
            <a:ext cx="5875020" cy="410718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3555365" y="302069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555365" y="272161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0954385" y="305879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704850" y="29083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12470" y="27832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701675" y="26904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43585" y="33921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733425" y="32327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731520" y="31273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12470" y="30206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2965" y="1162685"/>
            <a:ext cx="5875020" cy="4107180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10857230" y="304355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0857230" y="274447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412355" y="29311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7419975" y="28060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7409180" y="27133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7451090" y="34150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7440930" y="32556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7439025" y="31502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7419975" y="30435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90550" y="1375410"/>
            <a:ext cx="5875020" cy="410718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5260975" y="307403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260975" y="277495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648460" y="29616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656080" y="28365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645285" y="27438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687195" y="34455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677035" y="32861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675130" y="318071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656080" y="30740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669925" y="871220"/>
            <a:ext cx="5875020" cy="410718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5945505" y="290004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998845" y="2624455"/>
            <a:ext cx="2011680" cy="583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Malonyl CoA</a:t>
            </a:r>
            <a:endParaRPr lang="en-US" altLang="zh-CN" sz="1600">
              <a:solidFill>
                <a:srgbClr val="FF0000"/>
              </a:solidFill>
            </a:endParaRPr>
          </a:p>
          <a:p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495425" y="278701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03045" y="26619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492250" y="25692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534160" y="32708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524000" y="31115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522095" y="30060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503045" y="28994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4940" y="107251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23240" y="34182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30860" y="32931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20065" y="32004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76250" y="39668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66090" y="38074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64185" y="37020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77520" y="35382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119245" y="347599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119245" y="3201035"/>
            <a:ext cx="2011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CYP4A12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25820" y="1072515"/>
            <a:ext cx="5875020" cy="410718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792595" y="32219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00215" y="30892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789420" y="29546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800215" y="38138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788785" y="36683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800215" y="34975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796405" y="33496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388600" y="333692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388600" y="3061970"/>
            <a:ext cx="2011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CYP4A12A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5875020" y="1375410"/>
            <a:ext cx="5875020" cy="410718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0" y="145161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443355" y="35153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432560" y="33635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421765" y="32708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415415" y="40614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415415" y="39249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415415" y="37731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426845" y="35947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045710" y="366839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045710" y="3393440"/>
            <a:ext cx="448056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792595" y="3679190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00215" y="354647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789420" y="341185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800215" y="4271010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788785" y="412559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800215" y="3954780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796405" y="380682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388600" y="361759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469880" y="3331210"/>
            <a:ext cx="2011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" name="图片 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667500" y="1375410"/>
            <a:ext cx="5875020" cy="410718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5195" y="132588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443355" y="35153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432560" y="33635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421765" y="32708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415415" y="40614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415415" y="39249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1415415" y="37731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426845" y="35947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045710" y="366839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045710" y="3393440"/>
            <a:ext cx="448056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PPARα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762115" y="3912870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769735" y="378015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758940" y="364553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769735" y="4504690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758305" y="435927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769735" y="4188460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765925" y="4040505"/>
            <a:ext cx="519430" cy="7016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388600" y="386334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469880" y="3575685"/>
            <a:ext cx="201168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PPARα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9875" y="110299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82600" y="29698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71805" y="28562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61010" y="27654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54660" y="35159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54660" y="33794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54660" y="32277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66090" y="30492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847590" y="285623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847590" y="251841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A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197485" y="118300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49630" y="39471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838835" y="38334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828040" y="37426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821690" y="44932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21690" y="43567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821690" y="42049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833120" y="40265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423410" y="402653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423410" y="368681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A1</a:t>
            </a:r>
            <a:endParaRPr lang="en-US" altLang="zh-CN" sz="1600">
              <a:solidFill>
                <a:srgbClr val="FF0000"/>
              </a:solidFill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27065" y="1183005"/>
            <a:ext cx="5875020" cy="410718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7214870" y="32785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204075" y="31648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193280" y="30740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186930" y="38246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186930" y="36880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186930" y="353631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198360" y="33578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941050" y="334899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0788650" y="301815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A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5450" y="59309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09930" y="28460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14375" y="27374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707390" y="26111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13740" y="29711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81990" y="25114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959985" y="2787015"/>
            <a:ext cx="9677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959985" y="244729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ACOX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30705" y="102552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908800" y="37915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6928485" y="35782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907530" y="332041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98005" y="31419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876415" y="29952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908800" y="44564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908800" y="41751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922135" y="40449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924040" y="39350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362835" y="373189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362835" y="332232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299085" y="84518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689735" y="30295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694180" y="29210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687195" y="28479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693545" y="31546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661795" y="27330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421630" y="273748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ACOX1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421630" y="3029585"/>
            <a:ext cx="9677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6174105" y="932180"/>
            <a:ext cx="5875020" cy="410718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7404100" y="29279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408545" y="28194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401560" y="27463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7407910" y="30530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376160" y="26314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1021695" y="263588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ACOX1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1021695" y="2927985"/>
            <a:ext cx="967740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29335" y="94488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101725" y="30721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106170" y="29635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099185" y="28371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105535" y="31972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073785" y="27374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351780" y="286067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351780" y="252095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PT2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629920" y="44069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101725" y="30721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106170" y="29635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099185" y="28371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105535" y="31972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073785" y="27374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351780" y="300990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353685" y="273431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PT1A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0655" y="1113790"/>
            <a:ext cx="5875020" cy="410718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65190" y="111379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44855" y="30562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749300" y="29476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742315" y="28213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748665" y="31813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16915" y="27216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475480" y="299402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592955" y="268795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PT1A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482080" y="30899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486525" y="29813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479540" y="28549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485890" y="32150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454140" y="27552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0212705" y="333184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283825" y="298132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PT1A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3035" y="845185"/>
            <a:ext cx="5875020" cy="410718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8055" y="84518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558925" y="30638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63370" y="29552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556385" y="28289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562735" y="31889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168900" y="333946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286375" y="303339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A1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873875" y="31305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78320" y="30219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871335" y="28956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877685" y="32556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0483850" y="318897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0483850" y="289560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A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6238875" y="842010"/>
            <a:ext cx="5875020" cy="410718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887730" y="84201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558925" y="30638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63370" y="29552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556385" y="28289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562735" y="31889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168900" y="317119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240655" y="285115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B1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7056755" y="29933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061200" y="28848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7054215" y="27584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060565" y="31184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0864850" y="317754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0826750" y="289560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YP7B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0" y="117983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16305" y="29794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920750" y="28708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913765" y="27444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920115" y="310451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888365" y="264477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531360" y="3053715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531360" y="2713990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PT2</a:t>
            </a:r>
            <a:endParaRPr lang="en-US" altLang="zh-CN" sz="1600">
              <a:solidFill>
                <a:srgbClr val="FF0000"/>
              </a:solidFill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9645" y="1179830"/>
            <a:ext cx="5875020" cy="410718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958965" y="42684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963410" y="41598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956425" y="40335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962775" y="43935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932930" y="39522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0687685" y="4237990"/>
            <a:ext cx="210121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687685" y="3898265"/>
            <a:ext cx="1151255" cy="337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600">
                <a:solidFill>
                  <a:srgbClr val="FF0000"/>
                </a:solidFill>
              </a:rPr>
              <a:t>CPT2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08380" y="1221740"/>
            <a:ext cx="5875020" cy="410718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301105" y="40322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320790" y="37680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299835" y="35255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290310" y="33470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268720" y="31800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301105" y="469201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301105" y="44716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314440" y="42805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6316345" y="41706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007235" y="411797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793875" y="359664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CYP7B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83690" y="1466850"/>
            <a:ext cx="5875020" cy="410718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879590" y="40017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99275" y="37376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878320" y="34340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878955" y="31642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847205" y="28854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879590" y="46615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879590" y="44411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892925" y="42500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6894830" y="41402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59635" y="380301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159635" y="278384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BSEP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17040" y="1375410"/>
            <a:ext cx="5875020" cy="410718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6879590" y="40017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899275" y="373761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878320" y="34340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878955" y="31642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847205" y="28854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879590" y="46615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879590" y="444119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892925" y="42500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6894830" y="41402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69795" y="387413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159635" y="339344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CYP8B1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479425" y="129540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592445" y="26771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612130" y="23590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581650" y="20726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572125" y="185610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550535" y="16903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592445" y="33896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592445" y="31940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605780" y="29972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5607685" y="284924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879475" y="278765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49630" y="113538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736090" y="304038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755775" y="266509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725295" y="235013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715770" y="20288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694180" y="17773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749425" y="336042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751330" y="321246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6267450" y="315087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18945" y="1375410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6985000" y="381698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004685" y="35274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974205" y="32791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964680" y="29292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943090" y="26301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8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6998335" y="435610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7000240" y="414147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2308225" y="392049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actin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8" name="图片 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31165" y="1783715"/>
            <a:ext cx="5875020" cy="41071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019810" y="379285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4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027430" y="366776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5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16635" y="35750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7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058545" y="4276725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0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48385" y="411734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1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046480" y="401193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2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027430" y="3905250"/>
            <a:ext cx="51943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>
                <a:solidFill>
                  <a:srgbClr val="FFFF00"/>
                </a:solidFill>
              </a:rPr>
              <a:t>35 </a:t>
            </a:r>
            <a:endParaRPr lang="en-US" altLang="zh-CN" sz="1200">
              <a:solidFill>
                <a:srgbClr val="FFFF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2999105" y="379285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GAPDH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070225" y="3606165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FXR</a:t>
            </a:r>
            <a:endParaRPr lang="en-US" altLang="zh-CN" sz="160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928495" y="2087880"/>
            <a:ext cx="94361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solidFill>
                  <a:srgbClr val="FF0000"/>
                </a:solidFill>
              </a:rPr>
              <a:t>DMSO</a:t>
            </a:r>
            <a:endParaRPr lang="en-US" altLang="zh-CN" sz="160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19</Words>
  <Application>WPS 演示</Application>
  <PresentationFormat>宽屏</PresentationFormat>
  <Paragraphs>629</Paragraphs>
  <Slides>2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6</vt:i4>
      </vt:variant>
    </vt:vector>
  </HeadingPairs>
  <TitlesOfParts>
    <vt:vector size="33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Yiheng Zhang</cp:lastModifiedBy>
  <cp:revision>35</cp:revision>
  <dcterms:created xsi:type="dcterms:W3CDTF">2023-08-09T12:44:00Z</dcterms:created>
  <dcterms:modified xsi:type="dcterms:W3CDTF">2026-06-12T07:30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812BC946E98409A9B5B3F80F641F04D_13</vt:lpwstr>
  </property>
  <property fmtid="{D5CDD505-2E9C-101B-9397-08002B2CF9AE}" pid="3" name="KSOProductBuildVer">
    <vt:lpwstr>2052-12.1.0.26895</vt:lpwstr>
  </property>
</Properties>
</file>